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151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77887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3024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6155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77616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6469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9652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91889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6672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0417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2417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77686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47D329C-50D6-48E1-90EF-B762D9080056}" type="datetimeFigureOut">
              <a:rPr lang="en-GB" smtClean="0"/>
              <a:t>20/10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86DA6DE-D5B2-49E3-8D6A-42F2A51027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3058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A6D6A163-AF27-7A3D-7C07-6BE7AB19BE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07950721"/>
              </p:ext>
            </p:extLst>
          </p:nvPr>
        </p:nvGraphicFramePr>
        <p:xfrm>
          <a:off x="165204" y="1206626"/>
          <a:ext cx="9575591" cy="444474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968408">
                  <a:extLst>
                    <a:ext uri="{9D8B030D-6E8A-4147-A177-3AD203B41FA5}">
                      <a16:colId xmlns:a16="http://schemas.microsoft.com/office/drawing/2014/main" val="2037353164"/>
                    </a:ext>
                  </a:extLst>
                </a:gridCol>
                <a:gridCol w="968408">
                  <a:extLst>
                    <a:ext uri="{9D8B030D-6E8A-4147-A177-3AD203B41FA5}">
                      <a16:colId xmlns:a16="http://schemas.microsoft.com/office/drawing/2014/main" val="2590411335"/>
                    </a:ext>
                  </a:extLst>
                </a:gridCol>
                <a:gridCol w="819542">
                  <a:extLst>
                    <a:ext uri="{9D8B030D-6E8A-4147-A177-3AD203B41FA5}">
                      <a16:colId xmlns:a16="http://schemas.microsoft.com/office/drawing/2014/main" val="3739749575"/>
                    </a:ext>
                  </a:extLst>
                </a:gridCol>
                <a:gridCol w="819542">
                  <a:extLst>
                    <a:ext uri="{9D8B030D-6E8A-4147-A177-3AD203B41FA5}">
                      <a16:colId xmlns:a16="http://schemas.microsoft.com/office/drawing/2014/main" val="370335607"/>
                    </a:ext>
                  </a:extLst>
                </a:gridCol>
                <a:gridCol w="894767">
                  <a:extLst>
                    <a:ext uri="{9D8B030D-6E8A-4147-A177-3AD203B41FA5}">
                      <a16:colId xmlns:a16="http://schemas.microsoft.com/office/drawing/2014/main" val="720484545"/>
                    </a:ext>
                  </a:extLst>
                </a:gridCol>
                <a:gridCol w="817959">
                  <a:extLst>
                    <a:ext uri="{9D8B030D-6E8A-4147-A177-3AD203B41FA5}">
                      <a16:colId xmlns:a16="http://schemas.microsoft.com/office/drawing/2014/main" val="1718981231"/>
                    </a:ext>
                  </a:extLst>
                </a:gridCol>
                <a:gridCol w="894767">
                  <a:extLst>
                    <a:ext uri="{9D8B030D-6E8A-4147-A177-3AD203B41FA5}">
                      <a16:colId xmlns:a16="http://schemas.microsoft.com/office/drawing/2014/main" val="1745002406"/>
                    </a:ext>
                  </a:extLst>
                </a:gridCol>
                <a:gridCol w="1278013">
                  <a:extLst>
                    <a:ext uri="{9D8B030D-6E8A-4147-A177-3AD203B41FA5}">
                      <a16:colId xmlns:a16="http://schemas.microsoft.com/office/drawing/2014/main" val="4261329152"/>
                    </a:ext>
                  </a:extLst>
                </a:gridCol>
                <a:gridCol w="894767">
                  <a:extLst>
                    <a:ext uri="{9D8B030D-6E8A-4147-A177-3AD203B41FA5}">
                      <a16:colId xmlns:a16="http://schemas.microsoft.com/office/drawing/2014/main" val="3443344911"/>
                    </a:ext>
                  </a:extLst>
                </a:gridCol>
                <a:gridCol w="532110">
                  <a:extLst>
                    <a:ext uri="{9D8B030D-6E8A-4147-A177-3AD203B41FA5}">
                      <a16:colId xmlns:a16="http://schemas.microsoft.com/office/drawing/2014/main" val="3694998583"/>
                    </a:ext>
                  </a:extLst>
                </a:gridCol>
                <a:gridCol w="687308">
                  <a:extLst>
                    <a:ext uri="{9D8B030D-6E8A-4147-A177-3AD203B41FA5}">
                      <a16:colId xmlns:a16="http://schemas.microsoft.com/office/drawing/2014/main" val="1804496567"/>
                    </a:ext>
                  </a:extLst>
                </a:gridCol>
              </a:tblGrid>
              <a:tr h="480942"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Patien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Original treatmen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Retreatmen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Interval (months)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Age at first treatment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Cancer sub-sit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Concurrent </a:t>
                      </a:r>
                      <a:endParaRPr lang="en-GB" sz="1100" kern="100">
                        <a:effectLst/>
                      </a:endParaRPr>
                    </a:p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chemotherapy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ex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0827146"/>
                  </a:ext>
                </a:extLst>
              </a:tr>
              <a:tr h="563374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PTV dose(s) (Gy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Fraction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PTV dose(s) (Gy)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Fractions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First treatmen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 err="1">
                          <a:effectLst/>
                        </a:rPr>
                        <a:t>ReR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16637855"/>
                  </a:ext>
                </a:extLst>
              </a:tr>
              <a:tr h="563374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1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65.1/54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3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0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4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8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CC tonsil/posterior tongu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Ye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4114784"/>
                  </a:ext>
                </a:extLst>
              </a:tr>
              <a:tr h="563374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2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63/54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5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20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38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5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CC unknown primary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Ye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6863734"/>
                  </a:ext>
                </a:extLst>
              </a:tr>
              <a:tr h="373273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0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57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CC Oral Cancer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9663050"/>
                  </a:ext>
                </a:extLst>
              </a:tr>
              <a:tr h="195148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5.1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1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85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CC Scalp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1527349"/>
                  </a:ext>
                </a:extLst>
              </a:tr>
              <a:tr h="373273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8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79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SCC salivary duct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Fe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6484669"/>
                  </a:ext>
                </a:extLst>
              </a:tr>
              <a:tr h="373273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5.1/63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1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8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SCC scalp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495797"/>
                  </a:ext>
                </a:extLst>
              </a:tr>
              <a:tr h="373273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7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5.1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0/5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5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SCC left tonsil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Yes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0468081"/>
                  </a:ext>
                </a:extLst>
              </a:tr>
              <a:tr h="195148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8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5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2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16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72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CC paroti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No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No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0487422"/>
                  </a:ext>
                </a:extLst>
              </a:tr>
              <a:tr h="195148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9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5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2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/6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4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55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CC larynx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No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Yes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Male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8357514"/>
                  </a:ext>
                </a:extLst>
              </a:tr>
              <a:tr h="195148">
                <a:tc>
                  <a:txBody>
                    <a:bodyPr/>
                    <a:lstStyle/>
                    <a:p>
                      <a:pPr algn="r"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1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/6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30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63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84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>
                          <a:effectLst/>
                        </a:rPr>
                        <a:t>SCC parotid</a:t>
                      </a:r>
                      <a:endParaRPr lang="en-GB" sz="1100" kern="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No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No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800"/>
                        </a:spcAft>
                        <a:buNone/>
                      </a:pPr>
                      <a:r>
                        <a:rPr lang="en-GB" sz="1100" kern="0" dirty="0">
                          <a:effectLst/>
                        </a:rPr>
                        <a:t>Male</a:t>
                      </a:r>
                      <a:endParaRPr lang="en-GB" sz="1100" kern="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4959576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8A31C59-D93A-035A-769E-6ED5E924E9C8}"/>
              </a:ext>
            </a:extLst>
          </p:cNvPr>
          <p:cNvSpPr txBox="1"/>
          <p:nvPr/>
        </p:nvSpPr>
        <p:spPr>
          <a:xfrm>
            <a:off x="83723" y="929627"/>
            <a:ext cx="71602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/>
              <a:t>Table S1. </a:t>
            </a:r>
            <a:r>
              <a:rPr lang="en-GB" sz="1200" i="1" dirty="0"/>
              <a:t>Patient characteristics for the study, listing fractionation and patient characteristics for the audit.</a:t>
            </a:r>
            <a:endParaRPr lang="en-GB" sz="12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FB2BF8E-339D-4403-8471-0ACECAB572E3}"/>
              </a:ext>
            </a:extLst>
          </p:cNvPr>
          <p:cNvSpPr txBox="1"/>
          <p:nvPr/>
        </p:nvSpPr>
        <p:spPr>
          <a:xfrm>
            <a:off x="-1" y="135802"/>
            <a:ext cx="9906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800" b="1"/>
              <a:t>Supplementary materials</a:t>
            </a:r>
          </a:p>
          <a:p>
            <a:pPr algn="ctr"/>
            <a:endParaRPr lang="en-GB" sz="2800" b="1" dirty="0"/>
          </a:p>
        </p:txBody>
      </p:sp>
    </p:spTree>
    <p:extLst>
      <p:ext uri="{BB962C8B-B14F-4D97-AF65-F5344CB8AC3E}">
        <p14:creationId xmlns:p14="http://schemas.microsoft.com/office/powerpoint/2010/main" val="37823746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</TotalTime>
  <Words>185</Words>
  <Application>Microsoft Office PowerPoint</Application>
  <PresentationFormat>A4 Paper (210x297 mm)</PresentationFormat>
  <Paragraphs>1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>PHT (IPHIS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NASH, David (PORTSMOUTH HOSPITALS UNIVERSITY NHS TRUST)</dc:creator>
  <cp:lastModifiedBy>NASH, David (PORTSMOUTH HOSPITALS UNIVERSITY NHS TRUST)</cp:lastModifiedBy>
  <cp:revision>1</cp:revision>
  <dcterms:created xsi:type="dcterms:W3CDTF">2025-10-20T10:47:47Z</dcterms:created>
  <dcterms:modified xsi:type="dcterms:W3CDTF">2025-10-20T11:52:06Z</dcterms:modified>
</cp:coreProperties>
</file>